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20" autoAdjust="0"/>
    <p:restoredTop sz="94660"/>
  </p:normalViewPr>
  <p:slideViewPr>
    <p:cSldViewPr snapToGrid="0">
      <p:cViewPr varScale="1">
        <p:scale>
          <a:sx n="59" d="100"/>
          <a:sy n="59" d="100"/>
        </p:scale>
        <p:origin x="84" y="7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FAEB14-A0DA-413C-BD32-B9A1E1CB7ED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72CCC96-8401-4069-8042-B2E78C532B7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01E0E8-1514-4EE2-BCA8-838D4DA453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229414-5F59-4239-BD45-6D0594B107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A380BD-C3EC-4DEF-B9E2-BC4DEAA0E7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458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DF395F-1BB3-454B-A518-0F8F178E76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1C5102D-2272-47AD-BA73-D93A0CD031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B544D5-EFF4-4F7E-9319-2AC3ACB57E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AC522B-6F38-4837-9777-3126D4398D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E25A47-E766-4651-AAAC-2FA5D797B2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9885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F5A0FC7-B943-4666-85CE-1FE5D92555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8EBD3F-6810-4137-985D-3FDC57B1A6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48989B-7726-431D-82E1-23F5704119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E6C540-003E-4498-BE58-D455765BCF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8BDD52-5E18-4363-A930-4D77328E6E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12175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AAA6D2-7570-4076-B479-A6B9BEAD9A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5C61CD1-7ECB-4216-9D11-CF8D7728AC4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B1CAB2-5D88-4C00-9B1B-E3F5364DAE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A50248-645A-4032-A470-A0819B91F4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A465F6-B1B9-4D11-B36B-78A67B8AA0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67078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FD5746-FAF3-483E-8BB4-78567C1CD5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8E50D08-8948-4AC6-8556-7435ED4D8C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1659B8-8040-490A-B1BB-D0FE4C18EE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5566E5-280D-4E67-BCB1-1D018FB299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D09A0A-09B7-42A7-A1C2-7DB1DAA3B7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41701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A4CEF9-1257-47D5-A187-EA505A0C89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3D7EF2-577A-4A4A-862B-03FA1A63D52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1F01A57-A7D1-48EC-A2EC-6406C4FCD7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A4CE64-EBE6-495E-A77C-5D7CBF1485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BB6676-166D-475A-9B2E-2E8245262D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59B28C-F500-4F3A-9BAB-C4F1115935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90014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6A2923-741A-46E1-80BD-6F43A74118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812135-4947-49B4-A511-19ED2E602F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427C3A8-D54C-4CC8-9031-E19F5194EE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229DFBC-40B5-4CE3-8AB3-34111107C0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1424113-FED6-4F38-B272-115E7A1FDD7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760AFAB-5A3B-4809-9767-327AA79C9B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D621F0E-D8F3-4CA4-AAAA-B7D1C6DE92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DA3F71E-D8EE-496E-8BB4-7251EC1D06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7513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3A1C7D-DD09-4648-BC83-3DA39B7F74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BF36893-7D2D-4EF9-8EB4-A34649997F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FAE66F7-FF3A-4C56-B145-BBE3CDF0A0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703D9AB-787F-45EE-958F-338D844028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84573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55EE8ED-27C7-4D6C-A022-CE76D8035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9592EA3-D8F1-460E-812B-F480798766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9566240-9AF3-499B-B263-417B89D24F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75429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E92915-37EB-4C88-8BB1-1AB1420FE9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EE5F16-8BED-4C7B-B071-4CD5D847E1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C8CD66-CE7D-4F13-9A17-A17DCCC9C4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B81079-4924-49D5-8346-4652872116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EFEFA4-7A71-480E-92F0-8C14442D76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0BD7BA-0F90-40D2-A98E-C08E1DC5DF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51971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F0B292-F8BD-4395-95F6-9A400B4CAE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9EFA1A3-21B2-48A0-8980-62FF3A5AF44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8E64A9-EE47-4397-B748-E0EF85A2AD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2B340C-6BB6-4C9D-AAEB-8A83A8D4F4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B32CB6-E7DC-4516-B7E5-3FBD0E36DD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367DEE-120E-47AD-A372-3AB0144990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40879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37AF786-A348-4E78-86E4-8D5D45D2A1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6CF09E-FD97-4DF4-84A4-54582CE023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2C8C0F-43BD-47D8-A6C2-FE7163C7527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658B26-E781-4484-950D-EB55FD3B013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66DE0F-8290-477F-9C5F-84EF8CDD5A1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06240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886F2ABF-D3A7-41D3-B703-455AD5D41E2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23" t="620"/>
          <a:stretch/>
        </p:blipFill>
        <p:spPr>
          <a:xfrm>
            <a:off x="8414795" y="610389"/>
            <a:ext cx="3633271" cy="1686694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C8F372ED-D1C8-4236-8C2E-ADE80D30AF8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610389"/>
            <a:ext cx="8263467" cy="4131734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FF6B10AE-2B11-462E-8F79-E6F2DF64653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56867" y="3798332"/>
            <a:ext cx="5715000" cy="2857500"/>
          </a:xfrm>
          <a:prstGeom prst="rect">
            <a:avLst/>
          </a:prstGeom>
        </p:spPr>
      </p:pic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FD6C0E57-824E-4044-AA51-925AC66705A8}"/>
              </a:ext>
            </a:extLst>
          </p:cNvPr>
          <p:cNvCxnSpPr>
            <a:cxnSpLocks/>
          </p:cNvCxnSpPr>
          <p:nvPr/>
        </p:nvCxnSpPr>
        <p:spPr>
          <a:xfrm flipH="1">
            <a:off x="4360333" y="1058333"/>
            <a:ext cx="5164667" cy="3048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8DF4279C-296F-493A-BC01-CA719B7CFA15}"/>
              </a:ext>
            </a:extLst>
          </p:cNvPr>
          <p:cNvCxnSpPr>
            <a:cxnSpLocks/>
          </p:cNvCxnSpPr>
          <p:nvPr/>
        </p:nvCxnSpPr>
        <p:spPr>
          <a:xfrm flipH="1" flipV="1">
            <a:off x="7874000" y="1778000"/>
            <a:ext cx="3200400" cy="10662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itle 1">
            <a:extLst>
              <a:ext uri="{FF2B5EF4-FFF2-40B4-BE49-F238E27FC236}">
                <a16:creationId xmlns:a16="http://schemas.microsoft.com/office/drawing/2014/main" id="{E8899F3C-34D0-0D44-BC3E-AA3092EF15A4}"/>
              </a:ext>
            </a:extLst>
          </p:cNvPr>
          <p:cNvSpPr txBox="1">
            <a:spLocks/>
          </p:cNvSpPr>
          <p:nvPr/>
        </p:nvSpPr>
        <p:spPr>
          <a:xfrm>
            <a:off x="0" y="-88145"/>
            <a:ext cx="10515600" cy="1325563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dirty="0"/>
              <a:t>Supplemental Figure 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90BFF9C-BBB8-2C43-A78A-8804A6D8B4DF}"/>
              </a:ext>
            </a:extLst>
          </p:cNvPr>
          <p:cNvSpPr txBox="1"/>
          <p:nvPr/>
        </p:nvSpPr>
        <p:spPr>
          <a:xfrm>
            <a:off x="1993604" y="721955"/>
            <a:ext cx="494906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elected biological pathways that differ by gender for samples ≥ 60 day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FC05E4A-3B79-1E40-A2E2-25FF1FDA09DF}"/>
              </a:ext>
            </a:extLst>
          </p:cNvPr>
          <p:cNvSpPr txBox="1"/>
          <p:nvPr/>
        </p:nvSpPr>
        <p:spPr>
          <a:xfrm>
            <a:off x="8148581" y="439215"/>
            <a:ext cx="1203767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emale samples ≥ 60 days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18F255B-3528-4D49-9EF0-EB0F97FA325C}"/>
              </a:ext>
            </a:extLst>
          </p:cNvPr>
          <p:cNvSpPr txBox="1"/>
          <p:nvPr/>
        </p:nvSpPr>
        <p:spPr>
          <a:xfrm>
            <a:off x="11159391" y="556625"/>
            <a:ext cx="1040003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ale samples ≥ 60 days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7232B56-260D-7D4F-9A4F-83B80438235F}"/>
              </a:ext>
            </a:extLst>
          </p:cNvPr>
          <p:cNvSpPr txBox="1"/>
          <p:nvPr/>
        </p:nvSpPr>
        <p:spPr>
          <a:xfrm>
            <a:off x="7321737" y="3796956"/>
            <a:ext cx="542198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iological pathways common to males and females after 60 days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0018D9BE-5489-4B2A-8C29-6F82E921F716}"/>
              </a:ext>
            </a:extLst>
          </p:cNvPr>
          <p:cNvCxnSpPr>
            <a:cxnSpLocks/>
          </p:cNvCxnSpPr>
          <p:nvPr/>
        </p:nvCxnSpPr>
        <p:spPr>
          <a:xfrm>
            <a:off x="10346267" y="1651000"/>
            <a:ext cx="0" cy="214595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509013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5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opra, Sunita (NIH/NCI) [F]</dc:creator>
  <cp:lastModifiedBy>Chopra, Sunita (NIH/NCI) [F]</cp:lastModifiedBy>
  <cp:revision>3</cp:revision>
  <dcterms:created xsi:type="dcterms:W3CDTF">2022-05-12T17:09:25Z</dcterms:created>
  <dcterms:modified xsi:type="dcterms:W3CDTF">2022-05-12T17:10:41Z</dcterms:modified>
</cp:coreProperties>
</file>